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74" autoAdjust="0"/>
    <p:restoredTop sz="94660"/>
  </p:normalViewPr>
  <p:slideViewPr>
    <p:cSldViewPr snapToGrid="0">
      <p:cViewPr varScale="1">
        <p:scale>
          <a:sx n="65" d="100"/>
          <a:sy n="65" d="100"/>
        </p:scale>
        <p:origin x="217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sao\Desktop\&#23455;&#39443;&#12501;&#12449;&#12452;&#12523;&#30041;&#23398;&#24460;\&#35542;&#25991;\&#12513;&#12521;&#12488;&#12491;&#12531;&#38982;&#31890;&#33180;&#32048;&#32990;&#35542;&#25991;\RNAseq&#29983;&#12487;&#12540;&#12479;&#35542;&#25991;&#2999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sao\Desktop\&#23455;&#39443;&#12501;&#12449;&#12452;&#12523;&#30041;&#23398;&#24460;\&#35542;&#25991;\&#12513;&#12521;&#12488;&#12491;&#12531;&#38982;&#31890;&#33180;&#32048;&#32990;&#35542;&#25991;\RNAseq&#29983;&#12487;&#12540;&#12479;&#35542;&#25991;&#2999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sao\Desktop\&#23455;&#39443;&#12501;&#12449;&#12452;&#12523;&#30041;&#23398;&#24460;\&#35542;&#25991;\&#12513;&#12521;&#12488;&#12491;&#12531;&#38982;&#31890;&#33180;&#32048;&#32990;&#35542;&#25991;\RNAseq&#29983;&#12487;&#12540;&#12479;&#35542;&#25991;&#29992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isao\Desktop\&#23455;&#39443;&#12501;&#12449;&#12452;&#12523;&#30041;&#23398;&#24460;\&#35542;&#25991;\&#12513;&#12521;&#12488;&#12491;&#12531;&#38982;&#31890;&#33180;&#32048;&#32990;&#35542;&#25991;\RNAseq&#29983;&#12487;&#12540;&#12479;&#35542;&#25991;&#29992;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どっと!$I$7:$J$7</c:f>
                <c:numCache>
                  <c:formatCode>General</c:formatCode>
                  <c:ptCount val="2"/>
                </c:numCache>
              </c:numRef>
            </c:plus>
            <c:minus>
              <c:numRef>
                <c:f>どっと!$I$7:$J$7</c:f>
                <c:numCache>
                  <c:formatCode>General</c:formatCode>
                  <c:ptCount val="2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B$2:$AC$2</c:f>
              <c:numCache>
                <c:formatCode>General</c:formatCode>
                <c:ptCount val="2"/>
                <c:pt idx="0">
                  <c:v>1</c:v>
                </c:pt>
                <c:pt idx="1">
                  <c:v>2.77758774349684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571-4050-867C-6352DB3FC2DD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B$3:$AC$3</c:f>
              <c:numCache>
                <c:formatCode>General</c:formatCode>
                <c:ptCount val="2"/>
                <c:pt idx="0">
                  <c:v>1.2095529933140134</c:v>
                </c:pt>
                <c:pt idx="1">
                  <c:v>3.512755971666162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571-4050-867C-6352DB3FC2DD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B$4:$AC$4</c:f>
              <c:numCache>
                <c:formatCode>General</c:formatCode>
                <c:ptCount val="2"/>
                <c:pt idx="0">
                  <c:v>2.6142688544790791</c:v>
                </c:pt>
                <c:pt idx="1">
                  <c:v>7.797079421606275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571-4050-867C-6352DB3FC2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60264400"/>
        <c:axId val="760272928"/>
      </c:lineChart>
      <c:catAx>
        <c:axId val="760264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0272928"/>
        <c:crosses val="autoZero"/>
        <c:auto val="1"/>
        <c:lblAlgn val="ctr"/>
        <c:lblOffset val="100"/>
        <c:noMultiLvlLbl val="0"/>
      </c:catAx>
      <c:valAx>
        <c:axId val="760272928"/>
        <c:scaling>
          <c:orientation val="minMax"/>
          <c:max val="8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6026440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どっと!$I$7:$J$7</c:f>
                <c:numCache>
                  <c:formatCode>General</c:formatCode>
                  <c:ptCount val="2"/>
                </c:numCache>
              </c:numRef>
            </c:plus>
            <c:minus>
              <c:numRef>
                <c:f>どっと!$I$7:$J$7</c:f>
                <c:numCache>
                  <c:formatCode>General</c:formatCode>
                  <c:ptCount val="2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E$2:$AF$2</c:f>
              <c:numCache>
                <c:formatCode>General</c:formatCode>
                <c:ptCount val="2"/>
                <c:pt idx="0">
                  <c:v>1</c:v>
                </c:pt>
                <c:pt idx="1">
                  <c:v>1.947938460218545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FE2-482F-990E-648762D3916E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E$3:$AF$3</c:f>
              <c:numCache>
                <c:formatCode>General</c:formatCode>
                <c:ptCount val="2"/>
                <c:pt idx="0">
                  <c:v>0.26334636348736562</c:v>
                </c:pt>
                <c:pt idx="1">
                  <c:v>1.90612869081044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FE2-482F-990E-648762D3916E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E$4:$AF$4</c:f>
              <c:numCache>
                <c:formatCode>General</c:formatCode>
                <c:ptCount val="2"/>
                <c:pt idx="0">
                  <c:v>3.8984713104917059</c:v>
                </c:pt>
                <c:pt idx="1">
                  <c:v>6.46523207135575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FE2-482F-990E-648762D391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60264400"/>
        <c:axId val="760272928"/>
      </c:lineChart>
      <c:catAx>
        <c:axId val="760264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0272928"/>
        <c:crosses val="autoZero"/>
        <c:auto val="1"/>
        <c:lblAlgn val="ctr"/>
        <c:lblOffset val="100"/>
        <c:noMultiLvlLbl val="0"/>
      </c:catAx>
      <c:valAx>
        <c:axId val="760272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60264400"/>
        <c:crosses val="autoZero"/>
        <c:crossBetween val="between"/>
        <c:majorUnit val="4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どっと!$I$7:$J$7</c:f>
                <c:numCache>
                  <c:formatCode>General</c:formatCode>
                  <c:ptCount val="2"/>
                </c:numCache>
              </c:numRef>
            </c:plus>
            <c:minus>
              <c:numRef>
                <c:f>どっと!$I$7:$J$7</c:f>
                <c:numCache>
                  <c:formatCode>General</c:formatCode>
                  <c:ptCount val="2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H$2:$AI$2</c:f>
              <c:numCache>
                <c:formatCode>General</c:formatCode>
                <c:ptCount val="2"/>
                <c:pt idx="0">
                  <c:v>1</c:v>
                </c:pt>
                <c:pt idx="1">
                  <c:v>0.643678466232470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A2D-4C33-B54A-C8061D49DE42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H$3:$AI$3</c:f>
              <c:numCache>
                <c:formatCode>General</c:formatCode>
                <c:ptCount val="2"/>
                <c:pt idx="0">
                  <c:v>1.0940224446702138</c:v>
                </c:pt>
                <c:pt idx="1">
                  <c:v>0.67674610556860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A2D-4C33-B54A-C8061D49DE42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H$4:$AI$4</c:f>
              <c:numCache>
                <c:formatCode>General</c:formatCode>
                <c:ptCount val="2"/>
                <c:pt idx="0">
                  <c:v>0.73456728861220788</c:v>
                </c:pt>
                <c:pt idx="1">
                  <c:v>0.45593100199909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A2D-4C33-B54A-C8061D49DE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60264400"/>
        <c:axId val="760272928"/>
      </c:lineChart>
      <c:catAx>
        <c:axId val="760264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0272928"/>
        <c:crosses val="autoZero"/>
        <c:auto val="1"/>
        <c:lblAlgn val="ctr"/>
        <c:lblOffset val="100"/>
        <c:noMultiLvlLbl val="0"/>
      </c:catAx>
      <c:valAx>
        <c:axId val="760272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60264400"/>
        <c:crosses val="autoZero"/>
        <c:crossBetween val="between"/>
        <c:majorUnit val="0.60000000000000009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どっと!$I$7:$J$7</c:f>
                <c:numCache>
                  <c:formatCode>General</c:formatCode>
                  <c:ptCount val="2"/>
                </c:numCache>
              </c:numRef>
            </c:plus>
            <c:minus>
              <c:numRef>
                <c:f>どっと!$I$7:$J$7</c:f>
                <c:numCache>
                  <c:formatCode>General</c:formatCode>
                  <c:ptCount val="2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K$2:$AL$2</c:f>
              <c:numCache>
                <c:formatCode>General</c:formatCode>
                <c:ptCount val="2"/>
                <c:pt idx="0">
                  <c:v>1</c:v>
                </c:pt>
                <c:pt idx="1">
                  <c:v>0.5723680647707437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27F-454B-8C04-7E82051C3E59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K$3:$AL$3</c:f>
              <c:numCache>
                <c:formatCode>General</c:formatCode>
                <c:ptCount val="2"/>
                <c:pt idx="0">
                  <c:v>0.68066417502570675</c:v>
                </c:pt>
                <c:pt idx="1">
                  <c:v>0.385556737592390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27F-454B-8C04-7E82051C3E59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numRef>
              <c:f>どっと!$I$18:$J$18</c:f>
              <c:numCache>
                <c:formatCode>General</c:formatCode>
                <c:ptCount val="2"/>
              </c:numCache>
            </c:numRef>
          </c:cat>
          <c:val>
            <c:numRef>
              <c:f>どっと!$AK$4:$AL$4</c:f>
              <c:numCache>
                <c:formatCode>General</c:formatCode>
                <c:ptCount val="2"/>
                <c:pt idx="0">
                  <c:v>0.98348605270794365</c:v>
                </c:pt>
                <c:pt idx="1">
                  <c:v>0.4796320596626332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27F-454B-8C04-7E82051C3E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60264400"/>
        <c:axId val="760272928"/>
      </c:lineChart>
      <c:catAx>
        <c:axId val="760264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60272928"/>
        <c:crosses val="autoZero"/>
        <c:auto val="1"/>
        <c:lblAlgn val="ctr"/>
        <c:lblOffset val="100"/>
        <c:noMultiLvlLbl val="0"/>
      </c:catAx>
      <c:valAx>
        <c:axId val="7602729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760264400"/>
        <c:crosses val="autoZero"/>
        <c:crossBetween val="between"/>
        <c:majorUnit val="0.60000000000000009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822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598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7060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4907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616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439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76637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910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07360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34037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216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761C89-978E-4D4D-8864-4BD651501792}" type="datetimeFigureOut">
              <a:rPr kumimoji="1" lang="ja-JP" altLang="en-US" smtClean="0"/>
              <a:t>2022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9FF80-6175-4868-BEB2-BFA810E734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444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0BF5C52-643B-4538-A731-E816B65CE9BF}"/>
              </a:ext>
            </a:extLst>
          </p:cNvPr>
          <p:cNvSpPr txBox="1"/>
          <p:nvPr/>
        </p:nvSpPr>
        <p:spPr>
          <a:xfrm>
            <a:off x="14371" y="49870"/>
            <a:ext cx="21214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91A23B65-4048-40BC-A302-636EE3909045}"/>
              </a:ext>
            </a:extLst>
          </p:cNvPr>
          <p:cNvSpPr txBox="1"/>
          <p:nvPr/>
        </p:nvSpPr>
        <p:spPr>
          <a:xfrm rot="16200000">
            <a:off x="-239099" y="1306003"/>
            <a:ext cx="924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lu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9B4BD3F5-0EF5-43AC-AD28-65F2E7819508}"/>
              </a:ext>
            </a:extLst>
          </p:cNvPr>
          <p:cNvSpPr txBox="1"/>
          <p:nvPr/>
        </p:nvSpPr>
        <p:spPr>
          <a:xfrm rot="16200000">
            <a:off x="1073834" y="1315528"/>
            <a:ext cx="924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lu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116DC3BE-FAF7-4E82-914C-6C89617E7AF2}"/>
              </a:ext>
            </a:extLst>
          </p:cNvPr>
          <p:cNvSpPr txBox="1"/>
          <p:nvPr/>
        </p:nvSpPr>
        <p:spPr>
          <a:xfrm>
            <a:off x="459091" y="762497"/>
            <a:ext cx="888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X7B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2CE3AEF6-E6D8-4F66-B762-E4D0F2C23FF7}"/>
              </a:ext>
            </a:extLst>
          </p:cNvPr>
          <p:cNvSpPr txBox="1"/>
          <p:nvPr/>
        </p:nvSpPr>
        <p:spPr>
          <a:xfrm>
            <a:off x="1769456" y="762497"/>
            <a:ext cx="888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XCL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3AA84020-4F1D-4617-B632-7E82E005CE24}"/>
              </a:ext>
            </a:extLst>
          </p:cNvPr>
          <p:cNvSpPr txBox="1"/>
          <p:nvPr/>
        </p:nvSpPr>
        <p:spPr>
          <a:xfrm>
            <a:off x="715882" y="566112"/>
            <a:ext cx="18170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-regulated genes</a:t>
            </a:r>
            <a:endParaRPr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82DE4437-AF3C-4E88-A38E-E5285055E375}"/>
              </a:ext>
            </a:extLst>
          </p:cNvPr>
          <p:cNvGrpSpPr/>
          <p:nvPr/>
        </p:nvGrpSpPr>
        <p:grpSpPr>
          <a:xfrm>
            <a:off x="351286" y="1828201"/>
            <a:ext cx="1138521" cy="338554"/>
            <a:chOff x="538553" y="8047399"/>
            <a:chExt cx="1138521" cy="338554"/>
          </a:xfrm>
        </p:grpSpPr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2CAC4DE2-037B-499B-BA1E-154E808AF3DB}"/>
                </a:ext>
              </a:extLst>
            </p:cNvPr>
            <p:cNvSpPr txBox="1"/>
            <p:nvPr/>
          </p:nvSpPr>
          <p:spPr>
            <a:xfrm>
              <a:off x="538553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7CE7B77A-51CA-4468-B343-7512947E18A3}"/>
                </a:ext>
              </a:extLst>
            </p:cNvPr>
            <p:cNvSpPr txBox="1"/>
            <p:nvPr/>
          </p:nvSpPr>
          <p:spPr>
            <a:xfrm>
              <a:off x="1035653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8D56B7FA-568D-4675-BF93-6BD7411989A2}"/>
              </a:ext>
            </a:extLst>
          </p:cNvPr>
          <p:cNvGrpSpPr/>
          <p:nvPr/>
        </p:nvGrpSpPr>
        <p:grpSpPr>
          <a:xfrm>
            <a:off x="1624391" y="1828201"/>
            <a:ext cx="1152807" cy="338554"/>
            <a:chOff x="538553" y="8047399"/>
            <a:chExt cx="1152807" cy="338554"/>
          </a:xfrm>
        </p:grpSpPr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135E1247-56AE-466B-A81A-9DFEE7196E84}"/>
                </a:ext>
              </a:extLst>
            </p:cNvPr>
            <p:cNvSpPr txBox="1"/>
            <p:nvPr/>
          </p:nvSpPr>
          <p:spPr>
            <a:xfrm>
              <a:off x="538553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F2B7CA51-67F2-4841-BDA1-2BAEE591AC71}"/>
                </a:ext>
              </a:extLst>
            </p:cNvPr>
            <p:cNvSpPr txBox="1"/>
            <p:nvPr/>
          </p:nvSpPr>
          <p:spPr>
            <a:xfrm>
              <a:off x="1049939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9194E8CF-838D-C500-0C9D-DC215C7A8A88}"/>
              </a:ext>
            </a:extLst>
          </p:cNvPr>
          <p:cNvSpPr txBox="1"/>
          <p:nvPr/>
        </p:nvSpPr>
        <p:spPr>
          <a:xfrm>
            <a:off x="3514357" y="580663"/>
            <a:ext cx="18170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wn-regulated genes</a:t>
            </a:r>
            <a:endParaRPr lang="ja-JP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C371360E-0D6E-D27E-5155-146B01F22A45}"/>
              </a:ext>
            </a:extLst>
          </p:cNvPr>
          <p:cNvSpPr txBox="1"/>
          <p:nvPr/>
        </p:nvSpPr>
        <p:spPr>
          <a:xfrm>
            <a:off x="3265617" y="762497"/>
            <a:ext cx="888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F6</a:t>
            </a:r>
            <a:endParaRPr lang="ja-JP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537E9247-6B71-A630-2365-02AA9AF6AAF9}"/>
              </a:ext>
            </a:extLst>
          </p:cNvPr>
          <p:cNvSpPr txBox="1"/>
          <p:nvPr/>
        </p:nvSpPr>
        <p:spPr>
          <a:xfrm>
            <a:off x="4677231" y="762497"/>
            <a:ext cx="888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PV</a:t>
            </a:r>
          </a:p>
        </p:txBody>
      </p:sp>
      <p:graphicFrame>
        <p:nvGraphicFramePr>
          <p:cNvPr id="115" name="グラフ 114">
            <a:extLst>
              <a:ext uri="{FF2B5EF4-FFF2-40B4-BE49-F238E27FC236}">
                <a16:creationId xmlns:a16="http://schemas.microsoft.com/office/drawing/2014/main" id="{A21B9AB3-CB3D-4566-AF52-14FC13D0AC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1121198"/>
              </p:ext>
            </p:extLst>
          </p:nvPr>
        </p:nvGraphicFramePr>
        <p:xfrm>
          <a:off x="223117" y="924637"/>
          <a:ext cx="1330729" cy="10843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6" name="グラフ 115">
            <a:extLst>
              <a:ext uri="{FF2B5EF4-FFF2-40B4-BE49-F238E27FC236}">
                <a16:creationId xmlns:a16="http://schemas.microsoft.com/office/drawing/2014/main" id="{002B7425-5741-428D-91F7-D571BBCDE10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92984761"/>
              </p:ext>
            </p:extLst>
          </p:nvPr>
        </p:nvGraphicFramePr>
        <p:xfrm>
          <a:off x="1543154" y="919646"/>
          <a:ext cx="1330728" cy="10843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7" name="グラフ 116">
            <a:extLst>
              <a:ext uri="{FF2B5EF4-FFF2-40B4-BE49-F238E27FC236}">
                <a16:creationId xmlns:a16="http://schemas.microsoft.com/office/drawing/2014/main" id="{7E7499E8-1FC0-4CC8-A775-E11945D732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5480935"/>
              </p:ext>
            </p:extLst>
          </p:nvPr>
        </p:nvGraphicFramePr>
        <p:xfrm>
          <a:off x="2944427" y="912330"/>
          <a:ext cx="1330729" cy="10843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8" name="グラフ 117">
            <a:extLst>
              <a:ext uri="{FF2B5EF4-FFF2-40B4-BE49-F238E27FC236}">
                <a16:creationId xmlns:a16="http://schemas.microsoft.com/office/drawing/2014/main" id="{9A7B7E84-8076-43FB-B020-4F6948BB4F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5756585"/>
              </p:ext>
            </p:extLst>
          </p:nvPr>
        </p:nvGraphicFramePr>
        <p:xfrm>
          <a:off x="4366904" y="901812"/>
          <a:ext cx="1330729" cy="10843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01BC7360-4451-FE79-92E0-8C3BA65D5AA0}"/>
              </a:ext>
            </a:extLst>
          </p:cNvPr>
          <p:cNvSpPr txBox="1"/>
          <p:nvPr/>
        </p:nvSpPr>
        <p:spPr>
          <a:xfrm rot="16200000">
            <a:off x="2500006" y="1345134"/>
            <a:ext cx="924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lu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EE74BBE0-DBE3-71AB-FBBC-AF2BE97A02E1}"/>
              </a:ext>
            </a:extLst>
          </p:cNvPr>
          <p:cNvSpPr txBox="1"/>
          <p:nvPr/>
        </p:nvSpPr>
        <p:spPr>
          <a:xfrm rot="16200000">
            <a:off x="3915953" y="1345134"/>
            <a:ext cx="924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valu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1" name="グループ化 120">
            <a:extLst>
              <a:ext uri="{FF2B5EF4-FFF2-40B4-BE49-F238E27FC236}">
                <a16:creationId xmlns:a16="http://schemas.microsoft.com/office/drawing/2014/main" id="{B8DF0D12-D2DA-FD3B-DDA6-A7401E5B9658}"/>
              </a:ext>
            </a:extLst>
          </p:cNvPr>
          <p:cNvGrpSpPr/>
          <p:nvPr/>
        </p:nvGrpSpPr>
        <p:grpSpPr>
          <a:xfrm>
            <a:off x="3143630" y="1834623"/>
            <a:ext cx="1152807" cy="338554"/>
            <a:chOff x="538553" y="8047399"/>
            <a:chExt cx="1152807" cy="338554"/>
          </a:xfrm>
        </p:grpSpPr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98302B0A-28DB-3A65-E4EE-6E29FA8D9E59}"/>
                </a:ext>
              </a:extLst>
            </p:cNvPr>
            <p:cNvSpPr txBox="1"/>
            <p:nvPr/>
          </p:nvSpPr>
          <p:spPr>
            <a:xfrm>
              <a:off x="538553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7BFE0099-9F21-5E31-C321-8216097F1292}"/>
                </a:ext>
              </a:extLst>
            </p:cNvPr>
            <p:cNvSpPr txBox="1"/>
            <p:nvPr/>
          </p:nvSpPr>
          <p:spPr>
            <a:xfrm>
              <a:off x="1049939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id="{BD7589F6-05C9-A6C0-9544-5C56EF050533}"/>
              </a:ext>
            </a:extLst>
          </p:cNvPr>
          <p:cNvGrpSpPr/>
          <p:nvPr/>
        </p:nvGrpSpPr>
        <p:grpSpPr>
          <a:xfrm>
            <a:off x="4556359" y="1828201"/>
            <a:ext cx="1152807" cy="338554"/>
            <a:chOff x="538553" y="8047399"/>
            <a:chExt cx="1152807" cy="338554"/>
          </a:xfrm>
        </p:grpSpPr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F2D10B89-3991-95CA-D0E6-F43CF4C2E6E8}"/>
                </a:ext>
              </a:extLst>
            </p:cNvPr>
            <p:cNvSpPr txBox="1"/>
            <p:nvPr/>
          </p:nvSpPr>
          <p:spPr>
            <a:xfrm>
              <a:off x="538553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0FE77D41-B4F0-9F79-9CCF-584D613B5CED}"/>
                </a:ext>
              </a:extLst>
            </p:cNvPr>
            <p:cNvSpPr txBox="1"/>
            <p:nvPr/>
          </p:nvSpPr>
          <p:spPr>
            <a:xfrm>
              <a:off x="1049939" y="8047399"/>
              <a:ext cx="64142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der</a:t>
              </a:r>
            </a:p>
            <a:p>
              <a:pPr algn="ctr"/>
              <a:r>
                <a:rPr lang="en-US" altLang="ja-JP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atonin</a:t>
              </a:r>
              <a:endParaRPr lang="ja-JP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8" name="TextBox 18">
            <a:extLst>
              <a:ext uri="{FF2B5EF4-FFF2-40B4-BE49-F238E27FC236}">
                <a16:creationId xmlns:a16="http://schemas.microsoft.com/office/drawing/2014/main" id="{D3C31CE4-E142-DB84-F52C-D9EF947511E6}"/>
              </a:ext>
            </a:extLst>
          </p:cNvPr>
          <p:cNvSpPr txBox="1"/>
          <p:nvPr/>
        </p:nvSpPr>
        <p:spPr>
          <a:xfrm>
            <a:off x="1020028" y="847064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49" name="TextBox 18">
            <a:extLst>
              <a:ext uri="{FF2B5EF4-FFF2-40B4-BE49-F238E27FC236}">
                <a16:creationId xmlns:a16="http://schemas.microsoft.com/office/drawing/2014/main" id="{A82A3533-AC27-285E-60F7-9C3CDF7D467F}"/>
              </a:ext>
            </a:extLst>
          </p:cNvPr>
          <p:cNvSpPr txBox="1"/>
          <p:nvPr/>
        </p:nvSpPr>
        <p:spPr>
          <a:xfrm>
            <a:off x="2334192" y="942289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0" name="TextBox 18">
            <a:extLst>
              <a:ext uri="{FF2B5EF4-FFF2-40B4-BE49-F238E27FC236}">
                <a16:creationId xmlns:a16="http://schemas.microsoft.com/office/drawing/2014/main" id="{CBB60760-32F5-702B-E04A-D48C1878630C}"/>
              </a:ext>
            </a:extLst>
          </p:cNvPr>
          <p:cNvSpPr txBox="1"/>
          <p:nvPr/>
        </p:nvSpPr>
        <p:spPr>
          <a:xfrm>
            <a:off x="3746896" y="1111566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JP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51" name="TextBox 18">
            <a:extLst>
              <a:ext uri="{FF2B5EF4-FFF2-40B4-BE49-F238E27FC236}">
                <a16:creationId xmlns:a16="http://schemas.microsoft.com/office/drawing/2014/main" id="{4E4CEC90-94B1-B6D3-C611-0C587738A7AC}"/>
              </a:ext>
            </a:extLst>
          </p:cNvPr>
          <p:cNvSpPr txBox="1"/>
          <p:nvPr/>
        </p:nvSpPr>
        <p:spPr>
          <a:xfrm>
            <a:off x="5197780" y="1194991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6949231-FC7B-EAB3-29FE-6679D920BC28}"/>
              </a:ext>
            </a:extLst>
          </p:cNvPr>
          <p:cNvSpPr txBox="1"/>
          <p:nvPr/>
        </p:nvSpPr>
        <p:spPr>
          <a:xfrm>
            <a:off x="610660" y="2472222"/>
            <a:ext cx="4918569" cy="12464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1.</a:t>
            </a:r>
            <a:r>
              <a:rPr lang="en-US" altLang="ja-JP" sz="1000" kern="1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alidation of RNA-sequence data in top DEGs by real-time RT-PCR.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RNA expression levels of several top DEGs (COX7B, CXCL, TRAF6 and CENPV) were examined by real time RT-PCR.  Expression v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lues of each gene were normalized to those of GAPDH and expressed as a ratio of the before melatonin treatment sample of case No. 1. E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xpression values before and under melatonin treatment are shown as dot plots.  Blue line and dots; Case 1.  Orange line and dots; Case 2.  Gray line and dots; Case 3.  *, P&lt;0.01 vs. before melatonin.</a:t>
            </a:r>
            <a:endParaRPr lang="ja-JP" altLang="ja-JP" sz="10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08173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1</TotalTime>
  <Words>150</Words>
  <Application>Microsoft Office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功 田村</dc:creator>
  <cp:lastModifiedBy>MDPI-106</cp:lastModifiedBy>
  <cp:revision>44</cp:revision>
  <cp:lastPrinted>2022-02-01T08:48:14Z</cp:lastPrinted>
  <dcterms:created xsi:type="dcterms:W3CDTF">2021-12-23T13:31:58Z</dcterms:created>
  <dcterms:modified xsi:type="dcterms:W3CDTF">2022-06-16T11:09:52Z</dcterms:modified>
</cp:coreProperties>
</file>